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2115" autoAdjust="0"/>
  </p:normalViewPr>
  <p:slideViewPr>
    <p:cSldViewPr snapToGrid="0">
      <p:cViewPr varScale="1">
        <p:scale>
          <a:sx n="57" d="100"/>
          <a:sy n="57" d="100"/>
        </p:scale>
        <p:origin x="35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B210A2-1448-4D12-94D8-B6C93077E71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9D9E83-B7E9-4C2C-B50C-214E422168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0847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orting information</a:t>
            </a:r>
            <a:r>
              <a:rPr lang="ja-JP" altLang="en-US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3. Incomplete outcome data of short-term outcomes.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GA, small for gestational age.</a:t>
            </a:r>
            <a:r>
              <a:rPr lang="en-US" altLang="ja-JP" sz="1200" dirty="0">
                <a:solidFill>
                  <a:srgbClr val="FF0066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RDS,</a:t>
            </a:r>
            <a:r>
              <a:rPr lang="ja-JP" altLang="ja-JP" sz="12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r</a:t>
            </a:r>
            <a:r>
              <a:rPr lang="ja-JP" altLang="ja-JP" sz="12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espiratory distress syndrome. </a:t>
            </a:r>
            <a:r>
              <a:rPr lang="en-US" altLang="ja-JP" sz="12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BPD,</a:t>
            </a:r>
            <a:r>
              <a:rPr lang="ja-JP" altLang="ja-JP" sz="12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b</a:t>
            </a:r>
            <a:r>
              <a:rPr lang="ja-JP" altLang="ja-JP" sz="12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ronchopulmonary dysplasia</a:t>
            </a:r>
            <a:r>
              <a:rPr lang="en-US" altLang="ja-JP" sz="1200" dirty="0">
                <a:solidFill>
                  <a:srgbClr val="FF0066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PDA, p</a:t>
            </a:r>
            <a:r>
              <a:rPr lang="ja-JP" altLang="ja-JP" sz="12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atent ductus arteriosus</a:t>
            </a:r>
            <a:r>
              <a:rPr lang="en-US" altLang="ja-JP" sz="1200" dirty="0">
                <a:solidFill>
                  <a:srgbClr val="FF0066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IVH, i</a:t>
            </a:r>
            <a:r>
              <a:rPr lang="ja-JP" altLang="ja-JP" sz="12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ntraventricular hemorrhage</a:t>
            </a:r>
            <a:r>
              <a:rPr lang="en-US" altLang="ja-JP" sz="1200" dirty="0">
                <a:solidFill>
                  <a:srgbClr val="FF0066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NEC, n</a:t>
            </a:r>
            <a:r>
              <a:rPr lang="ja-JP" altLang="ja-JP" sz="12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ecrotizing </a:t>
            </a:r>
            <a:r>
              <a:rPr lang="en-US" altLang="ja-JP" sz="12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e</a:t>
            </a:r>
            <a:r>
              <a:rPr lang="ja-JP" altLang="ja-JP" sz="12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nterocolitis</a:t>
            </a:r>
            <a:r>
              <a:rPr lang="en-US" altLang="ja-JP" sz="1200" dirty="0">
                <a:solidFill>
                  <a:srgbClr val="FF0066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ROP, r</a:t>
            </a:r>
            <a:r>
              <a:rPr lang="ja-JP" altLang="ja-JP" sz="12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etinopathy of prematurity</a:t>
            </a:r>
            <a:r>
              <a:rPr lang="en-US" altLang="ja-JP" sz="1200" dirty="0">
                <a:solidFill>
                  <a:srgbClr val="FF0066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gSO</a:t>
            </a:r>
            <a:r>
              <a:rPr lang="en-US" altLang="ja-JP" sz="12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4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,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agnesium sulphate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9D9E83-B7E9-4C2C-B50C-214E4221688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55389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E73A4-433C-4816-9520-01D0AF978DC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6F6F7-6D9F-4671-BFA9-D094EF602F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3956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E73A4-433C-4816-9520-01D0AF978DC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6F6F7-6D9F-4671-BFA9-D094EF602F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402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E73A4-433C-4816-9520-01D0AF978DC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6F6F7-6D9F-4671-BFA9-D094EF602F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9203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E73A4-433C-4816-9520-01D0AF978DC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6F6F7-6D9F-4671-BFA9-D094EF602F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657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E73A4-433C-4816-9520-01D0AF978DC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6F6F7-6D9F-4671-BFA9-D094EF602F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793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E73A4-433C-4816-9520-01D0AF978DC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6F6F7-6D9F-4671-BFA9-D094EF602F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9016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E73A4-433C-4816-9520-01D0AF978DC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6F6F7-6D9F-4671-BFA9-D094EF602F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119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E73A4-433C-4816-9520-01D0AF978DC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6F6F7-6D9F-4671-BFA9-D094EF602F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8869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E73A4-433C-4816-9520-01D0AF978DC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6F6F7-6D9F-4671-BFA9-D094EF602F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17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E73A4-433C-4816-9520-01D0AF978DC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6F6F7-6D9F-4671-BFA9-D094EF602F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8644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E73A4-433C-4816-9520-01D0AF978DC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6F6F7-6D9F-4671-BFA9-D094EF602F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3708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8E73A4-433C-4816-9520-01D0AF978DC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F6F6F7-6D9F-4671-BFA9-D094EF602F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9797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B56E9E9B-10CF-1EE2-C89F-968E5717BE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714432"/>
              </p:ext>
            </p:extLst>
          </p:nvPr>
        </p:nvGraphicFramePr>
        <p:xfrm>
          <a:off x="471488" y="1771651"/>
          <a:ext cx="5915024" cy="8649967"/>
        </p:xfrm>
        <a:graphic>
          <a:graphicData uri="http://schemas.openxmlformats.org/drawingml/2006/table">
            <a:tbl>
              <a:tblPr/>
              <a:tblGrid>
                <a:gridCol w="1718924">
                  <a:extLst>
                    <a:ext uri="{9D8B030D-6E8A-4147-A177-3AD203B41FA5}">
                      <a16:colId xmlns:a16="http://schemas.microsoft.com/office/drawing/2014/main" val="2124724228"/>
                    </a:ext>
                  </a:extLst>
                </a:gridCol>
                <a:gridCol w="996012">
                  <a:extLst>
                    <a:ext uri="{9D8B030D-6E8A-4147-A177-3AD203B41FA5}">
                      <a16:colId xmlns:a16="http://schemas.microsoft.com/office/drawing/2014/main" val="896801911"/>
                    </a:ext>
                  </a:extLst>
                </a:gridCol>
                <a:gridCol w="800022">
                  <a:extLst>
                    <a:ext uri="{9D8B030D-6E8A-4147-A177-3AD203B41FA5}">
                      <a16:colId xmlns:a16="http://schemas.microsoft.com/office/drawing/2014/main" val="3440125792"/>
                    </a:ext>
                  </a:extLst>
                </a:gridCol>
                <a:gridCol w="800022">
                  <a:extLst>
                    <a:ext uri="{9D8B030D-6E8A-4147-A177-3AD203B41FA5}">
                      <a16:colId xmlns:a16="http://schemas.microsoft.com/office/drawing/2014/main" val="2825196290"/>
                    </a:ext>
                  </a:extLst>
                </a:gridCol>
                <a:gridCol w="800022">
                  <a:extLst>
                    <a:ext uri="{9D8B030D-6E8A-4147-A177-3AD203B41FA5}">
                      <a16:colId xmlns:a16="http://schemas.microsoft.com/office/drawing/2014/main" val="2794733073"/>
                    </a:ext>
                  </a:extLst>
                </a:gridCol>
                <a:gridCol w="800022">
                  <a:extLst>
                    <a:ext uri="{9D8B030D-6E8A-4147-A177-3AD203B41FA5}">
                      <a16:colId xmlns:a16="http://schemas.microsoft.com/office/drawing/2014/main" val="2887815588"/>
                    </a:ext>
                  </a:extLst>
                </a:gridCol>
              </a:tblGrid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gSO</a:t>
                      </a:r>
                      <a:r>
                        <a:rPr lang="en-US" sz="8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lacebo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3493890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nalyzed cases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ropout rate (%)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nalyzed cases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ropout rate (%)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550783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ternal adverse events (any symptom)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rowther 200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35/535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27/52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7766930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use 200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78/108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25/1141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8033902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olon 201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/15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/15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7383458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ternal adverse events (headache)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rret 200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86/28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78/27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1068767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olon 201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/15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/15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5379481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ternal adverse events (dizziness)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rowther 200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35/535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27/52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7207486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olon 201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/15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/15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9468699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eonatal adverse events (any symptom)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ittrendorf 2002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/3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9/29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1569557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rassinower 2015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61/461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86/58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2422368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GA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aradidis 2012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8/4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9/39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8387937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rassinower 2015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61/461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86/58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6782128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Use of ventilator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rowther 200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20/629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15/62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6934329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rret 200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52/352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6/33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8622164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use 200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71/117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44/124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831422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olon 201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7/1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/1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6328010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olf 202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3/34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7/33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1435245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Use of vasopressor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use 200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71/117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44/124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6159442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aradidis 2012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8/4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9/39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9179947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olf 202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3/34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7/33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8918807"/>
                  </a:ext>
                </a:extLst>
              </a:tr>
              <a:tr h="246812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eonatal asphyxia </a:t>
                      </a:r>
                    </a:p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5 min Apgar score &lt;7)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rret 200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52/352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6/33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0558517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use 200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71/117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40/124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3419568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olf 202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3/34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7/33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2396780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DS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rret 200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52/352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6/33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9406376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use 200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71/117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44/124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9846220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olon 201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7/1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/1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5331440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BPD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rowther 200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20/629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15/62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7157737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use 200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71/117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44/124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563206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olf 202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3/34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7/33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579953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A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use 200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71/117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44/124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309810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aradidis 2012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8/4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9/39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2881620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olf 202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3/34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7/33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1919808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VH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ittrendorf 2002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/3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9/29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9071806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rowther 200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96/629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.2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86/62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.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1605549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rret 200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1/352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1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24/33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569466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use 200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12/117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.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84/124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.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2351457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olf 202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3/34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7/33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2911399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eizure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rret 200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52/352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6/33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400655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use 200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71/117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44/124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99615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olf 202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3/34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7/33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8137034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epsis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use 200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71/117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44/124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276756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olon 201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7/1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/1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6305401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EC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rowther 200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20/629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15/62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0698074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rret 200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52/352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6/336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3412580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use 200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71/117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44/124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7145185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olf 202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3/34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7/33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5720410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P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use 2008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71/117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44/1244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8197833"/>
                  </a:ext>
                </a:extLst>
              </a:tr>
              <a:tr h="17503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255" marR="4255" marT="42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olf 202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3/343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7/337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4255" marR="4255" marT="42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312403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688563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</TotalTime>
  <Words>444</Words>
  <Application>Microsoft Office PowerPoint</Application>
  <PresentationFormat>ワイド画面</PresentationFormat>
  <Paragraphs>29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小林 玲</dc:creator>
  <cp:lastModifiedBy>小林 玲</cp:lastModifiedBy>
  <cp:revision>8</cp:revision>
  <dcterms:created xsi:type="dcterms:W3CDTF">2022-12-31T05:12:45Z</dcterms:created>
  <dcterms:modified xsi:type="dcterms:W3CDTF">2023-06-06T15:21:48Z</dcterms:modified>
</cp:coreProperties>
</file>